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14630400" cy="10972800"/>
  <p:notesSz cx="6858000" cy="9144000"/>
  <p:defaultTextStyle>
    <a:defPPr>
      <a:defRPr lang="en-US"/>
    </a:defPPr>
    <a:lvl1pPr marL="0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1pPr>
    <a:lvl2pPr marL="570586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2pPr>
    <a:lvl3pPr marL="1141171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3pPr>
    <a:lvl4pPr marL="1711757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4pPr>
    <a:lvl5pPr marL="2282342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5pPr>
    <a:lvl6pPr marL="2852928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6pPr>
    <a:lvl7pPr marL="3423514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7pPr>
    <a:lvl8pPr marL="3994099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8pPr>
    <a:lvl9pPr marL="4564685" algn="l" defTabSz="1141171" rtl="0" eaLnBrk="1" latinLnBrk="0" hangingPunct="1">
      <a:defRPr sz="224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0"/>
    <p:restoredTop sz="94666"/>
  </p:normalViewPr>
  <p:slideViewPr>
    <p:cSldViewPr snapToGrid="0" snapToObjects="1">
      <p:cViewPr varScale="1">
        <p:scale>
          <a:sx n="68" d="100"/>
          <a:sy n="68" d="100"/>
        </p:scale>
        <p:origin x="104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1795781"/>
            <a:ext cx="12435840" cy="3820160"/>
          </a:xfrm>
        </p:spPr>
        <p:txBody>
          <a:bodyPr anchor="b"/>
          <a:lstStyle>
            <a:lvl1pPr algn="ctr"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5763261"/>
            <a:ext cx="10972800" cy="2649219"/>
          </a:xfrm>
        </p:spPr>
        <p:txBody>
          <a:bodyPr/>
          <a:lstStyle>
            <a:lvl1pPr marL="0" indent="0" algn="ctr">
              <a:buNone/>
              <a:defRPr sz="3840"/>
            </a:lvl1pPr>
            <a:lvl2pPr marL="731520" indent="0" algn="ctr">
              <a:buNone/>
              <a:defRPr sz="3200"/>
            </a:lvl2pPr>
            <a:lvl3pPr marL="1463040" indent="0" algn="ctr">
              <a:buNone/>
              <a:defRPr sz="2880"/>
            </a:lvl3pPr>
            <a:lvl4pPr marL="2194560" indent="0" algn="ctr">
              <a:buNone/>
              <a:defRPr sz="2560"/>
            </a:lvl4pPr>
            <a:lvl5pPr marL="2926080" indent="0" algn="ctr">
              <a:buNone/>
              <a:defRPr sz="2560"/>
            </a:lvl5pPr>
            <a:lvl6pPr marL="3657600" indent="0" algn="ctr">
              <a:buNone/>
              <a:defRPr sz="2560"/>
            </a:lvl6pPr>
            <a:lvl7pPr marL="4389120" indent="0" algn="ctr">
              <a:buNone/>
              <a:defRPr sz="2560"/>
            </a:lvl7pPr>
            <a:lvl8pPr marL="5120640" indent="0" algn="ctr">
              <a:buNone/>
              <a:defRPr sz="2560"/>
            </a:lvl8pPr>
            <a:lvl9pPr marL="5852160" indent="0" algn="ctr">
              <a:buNone/>
              <a:defRPr sz="25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704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161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1" y="584200"/>
            <a:ext cx="3154680" cy="92989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1" y="584200"/>
            <a:ext cx="9281160" cy="9298941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97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084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1" y="2735583"/>
            <a:ext cx="12618720" cy="4564379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1" y="7343143"/>
            <a:ext cx="12618720" cy="2400299"/>
          </a:xfrm>
        </p:spPr>
        <p:txBody>
          <a:bodyPr/>
          <a:lstStyle>
            <a:lvl1pPr marL="0" indent="0">
              <a:buNone/>
              <a:defRPr sz="3840">
                <a:solidFill>
                  <a:schemeClr val="tx1"/>
                </a:solidFill>
              </a:defRPr>
            </a:lvl1pPr>
            <a:lvl2pPr marL="7315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930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2921000"/>
            <a:ext cx="6217920" cy="69621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2921000"/>
            <a:ext cx="6217920" cy="69621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80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584202"/>
            <a:ext cx="12618720" cy="2120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7" y="2689861"/>
            <a:ext cx="6189344" cy="131825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7" y="4008120"/>
            <a:ext cx="6189344" cy="58953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1" y="2689861"/>
            <a:ext cx="6219826" cy="131825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1" y="4008120"/>
            <a:ext cx="6219826" cy="58953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87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790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74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31520"/>
            <a:ext cx="4718685" cy="256032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1579882"/>
            <a:ext cx="7406640" cy="7797800"/>
          </a:xfrm>
        </p:spPr>
        <p:txBody>
          <a:bodyPr/>
          <a:lstStyle>
            <a:lvl1pPr>
              <a:defRPr sz="5120"/>
            </a:lvl1pPr>
            <a:lvl2pPr>
              <a:defRPr sz="4480"/>
            </a:lvl2pPr>
            <a:lvl3pPr>
              <a:defRPr sz="384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3291840"/>
            <a:ext cx="4718685" cy="6098541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08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31520"/>
            <a:ext cx="4718685" cy="256032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1579882"/>
            <a:ext cx="7406640" cy="7797800"/>
          </a:xfrm>
        </p:spPr>
        <p:txBody>
          <a:bodyPr anchor="t"/>
          <a:lstStyle>
            <a:lvl1pPr marL="0" indent="0">
              <a:buNone/>
              <a:defRPr sz="5120"/>
            </a:lvl1pPr>
            <a:lvl2pPr marL="731520" indent="0">
              <a:buNone/>
              <a:defRPr sz="4480"/>
            </a:lvl2pPr>
            <a:lvl3pPr marL="1463040" indent="0">
              <a:buNone/>
              <a:defRPr sz="384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3291840"/>
            <a:ext cx="4718685" cy="6098541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570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584202"/>
            <a:ext cx="12618720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2921000"/>
            <a:ext cx="12618720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10170162"/>
            <a:ext cx="329184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ADC3AE-520E-374E-8316-F3C693B0F3B6}" type="datetimeFigureOut">
              <a:rPr lang="en-US" smtClean="0"/>
              <a:t>1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10170162"/>
            <a:ext cx="493776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10170162"/>
            <a:ext cx="329184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FF097E-EDA8-5A4D-8DE6-B793A57BB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345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63040" rtl="0" eaLnBrk="1" latinLnBrk="0" hangingPunct="1">
        <a:lnSpc>
          <a:spcPct val="90000"/>
        </a:lnSpc>
        <a:spcBef>
          <a:spcPct val="0"/>
        </a:spcBef>
        <a:buNone/>
        <a:defRPr sz="70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60" indent="-365760" algn="l" defTabSz="146304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4480" kern="1200">
          <a:solidFill>
            <a:schemeClr val="tx1"/>
          </a:solidFill>
          <a:latin typeface="+mn-lt"/>
          <a:ea typeface="+mn-ea"/>
          <a:cs typeface="+mn-cs"/>
        </a:defRPr>
      </a:lvl1pPr>
      <a:lvl2pPr marL="10972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>
            <a:extLst>
              <a:ext uri="{FF2B5EF4-FFF2-40B4-BE49-F238E27FC236}">
                <a16:creationId xmlns:a16="http://schemas.microsoft.com/office/drawing/2014/main" id="{743BE60A-3D11-0D46-B958-CB7D17594CD1}"/>
              </a:ext>
            </a:extLst>
          </p:cNvPr>
          <p:cNvGrpSpPr/>
          <p:nvPr/>
        </p:nvGrpSpPr>
        <p:grpSpPr>
          <a:xfrm>
            <a:off x="1184963" y="5513646"/>
            <a:ext cx="5383763" cy="5264664"/>
            <a:chOff x="3933545" y="347253"/>
            <a:chExt cx="5383763" cy="5264664"/>
          </a:xfrm>
        </p:grpSpPr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8D32BD6A-7C9B-1D4D-8467-60820925898C}"/>
                </a:ext>
              </a:extLst>
            </p:cNvPr>
            <p:cNvSpPr txBox="1"/>
            <p:nvPr/>
          </p:nvSpPr>
          <p:spPr>
            <a:xfrm rot="16200000">
              <a:off x="6635334" y="1061325"/>
              <a:ext cx="16517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6.9 degree 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2AA1CA11-4B55-B34D-9A8E-2AF5E9D175EF}"/>
                </a:ext>
              </a:extLst>
            </p:cNvPr>
            <p:cNvSpPr txBox="1"/>
            <p:nvPr/>
          </p:nvSpPr>
          <p:spPr>
            <a:xfrm rot="16200000">
              <a:off x="7141992" y="1051824"/>
              <a:ext cx="167075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5.7 degree 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9ECB9868-2580-0C41-AC09-115E63D94EB4}"/>
                </a:ext>
              </a:extLst>
            </p:cNvPr>
            <p:cNvSpPr txBox="1"/>
            <p:nvPr/>
          </p:nvSpPr>
          <p:spPr>
            <a:xfrm rot="16200000">
              <a:off x="5560721" y="1061325"/>
              <a:ext cx="16517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1.1 degree 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69D341E5-3385-0C44-97E7-3F35823603CB}"/>
                </a:ext>
              </a:extLst>
            </p:cNvPr>
            <p:cNvSpPr txBox="1"/>
            <p:nvPr/>
          </p:nvSpPr>
          <p:spPr>
            <a:xfrm rot="16200000">
              <a:off x="6066882" y="1051825"/>
              <a:ext cx="16707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8.8 degree 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D5AA355-D690-3342-9326-B5F5BE8F3C9A}"/>
                </a:ext>
              </a:extLst>
            </p:cNvPr>
            <p:cNvSpPr txBox="1"/>
            <p:nvPr/>
          </p:nvSpPr>
          <p:spPr>
            <a:xfrm rot="16200000">
              <a:off x="4522575" y="1051825"/>
              <a:ext cx="16707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4.3 degree 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ACEAF973-E358-C943-91C1-98F9F0A50393}"/>
                </a:ext>
              </a:extLst>
            </p:cNvPr>
            <p:cNvSpPr txBox="1"/>
            <p:nvPr/>
          </p:nvSpPr>
          <p:spPr>
            <a:xfrm rot="16200000">
              <a:off x="4040286" y="110164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5 degree 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386F3F51-F761-4C4C-B673-A76E1E8DD151}"/>
                </a:ext>
              </a:extLst>
            </p:cNvPr>
            <p:cNvSpPr txBox="1"/>
            <p:nvPr/>
          </p:nvSpPr>
          <p:spPr>
            <a:xfrm rot="16200000">
              <a:off x="5061454" y="110164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3 degree 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5BCECA3F-7FAA-B045-AE51-D5F6FC99EBB4}"/>
                </a:ext>
              </a:extLst>
            </p:cNvPr>
            <p:cNvGrpSpPr/>
            <p:nvPr/>
          </p:nvGrpSpPr>
          <p:grpSpPr>
            <a:xfrm>
              <a:off x="3933545" y="929102"/>
              <a:ext cx="5383763" cy="4682815"/>
              <a:chOff x="3933545" y="929102"/>
              <a:chExt cx="5383763" cy="4682815"/>
            </a:xfrm>
          </p:grpSpPr>
          <p:pic>
            <p:nvPicPr>
              <p:cNvPr id="87" name="Picture 86">
                <a:extLst>
                  <a:ext uri="{FF2B5EF4-FFF2-40B4-BE49-F238E27FC236}">
                    <a16:creationId xmlns:a16="http://schemas.microsoft.com/office/drawing/2014/main" id="{C7143309-213C-8548-9156-C6F679B419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bright="6000" contrast="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16" t="23395" r="31766" b="20669"/>
              <a:stretch/>
            </p:blipFill>
            <p:spPr>
              <a:xfrm>
                <a:off x="3933545" y="1972978"/>
                <a:ext cx="5383763" cy="3638939"/>
              </a:xfrm>
              <a:prstGeom prst="rect">
                <a:avLst/>
              </a:prstGeom>
            </p:spPr>
          </p:pic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E71142A4-5CB6-5749-BBE7-7A48C2C47B2C}"/>
                  </a:ext>
                </a:extLst>
              </p:cNvPr>
              <p:cNvSpPr txBox="1"/>
              <p:nvPr/>
            </p:nvSpPr>
            <p:spPr>
              <a:xfrm rot="16200000">
                <a:off x="3653146" y="1334181"/>
                <a:ext cx="10871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0 bp Ladder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2CA343AE-5F96-9548-ACCB-7BB114268062}"/>
                  </a:ext>
                </a:extLst>
              </p:cNvPr>
              <p:cNvSpPr txBox="1"/>
              <p:nvPr/>
            </p:nvSpPr>
            <p:spPr>
              <a:xfrm rot="16200000">
                <a:off x="8256018" y="1680331"/>
                <a:ext cx="15711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1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</a:t>
                </a:r>
              </a:p>
            </p:txBody>
          </p: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56F380FA-0AA3-0947-9962-867A2D469BF9}"/>
                </a:ext>
              </a:extLst>
            </p:cNvPr>
            <p:cNvSpPr txBox="1"/>
            <p:nvPr/>
          </p:nvSpPr>
          <p:spPr>
            <a:xfrm rot="16200000">
              <a:off x="7658510" y="110164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5 degree </a:t>
              </a:r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B015CE87-6130-6841-B808-EA89AE0F557C}"/>
              </a:ext>
            </a:extLst>
          </p:cNvPr>
          <p:cNvGrpSpPr/>
          <p:nvPr/>
        </p:nvGrpSpPr>
        <p:grpSpPr>
          <a:xfrm>
            <a:off x="9136352" y="188569"/>
            <a:ext cx="3277040" cy="5215211"/>
            <a:chOff x="5027316" y="346515"/>
            <a:chExt cx="3277040" cy="5215211"/>
          </a:xfrm>
        </p:grpSpPr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648FD003-AAA7-0444-A82A-AF92048FD2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66" t="24398" r="18210" b="19092"/>
            <a:stretch/>
          </p:blipFill>
          <p:spPr>
            <a:xfrm>
              <a:off x="5027316" y="1885465"/>
              <a:ext cx="3277040" cy="3676261"/>
            </a:xfrm>
            <a:prstGeom prst="rect">
              <a:avLst/>
            </a:prstGeom>
          </p:spPr>
        </p:pic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7BABBB31-BD8A-9747-8B4B-60B32522F3B2}"/>
                </a:ext>
              </a:extLst>
            </p:cNvPr>
            <p:cNvSpPr txBox="1"/>
            <p:nvPr/>
          </p:nvSpPr>
          <p:spPr>
            <a:xfrm rot="16200000">
              <a:off x="4946433" y="100127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8 degree 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BA9921D4-9EAD-9247-8D20-0CB369FBEBF9}"/>
                </a:ext>
              </a:extLst>
            </p:cNvPr>
            <p:cNvSpPr txBox="1"/>
            <p:nvPr/>
          </p:nvSpPr>
          <p:spPr>
            <a:xfrm rot="16200000">
              <a:off x="4622237" y="1265330"/>
              <a:ext cx="10871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bp Ladder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FD724F71-AEE7-6B42-908A-288876BB97BF}"/>
                </a:ext>
              </a:extLst>
            </p:cNvPr>
            <p:cNvSpPr txBox="1"/>
            <p:nvPr/>
          </p:nvSpPr>
          <p:spPr>
            <a:xfrm rot="16200000">
              <a:off x="5481602" y="100127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9 degree 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7A2FEF66-5623-F745-9B32-49E22F49413E}"/>
                </a:ext>
              </a:extLst>
            </p:cNvPr>
            <p:cNvSpPr txBox="1"/>
            <p:nvPr/>
          </p:nvSpPr>
          <p:spPr>
            <a:xfrm rot="16200000">
              <a:off x="5992088" y="100127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 degree 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5DDBFDC4-32C0-254E-8351-1634AA4DB014}"/>
                </a:ext>
              </a:extLst>
            </p:cNvPr>
            <p:cNvSpPr txBox="1"/>
            <p:nvPr/>
          </p:nvSpPr>
          <p:spPr>
            <a:xfrm rot="16200000">
              <a:off x="6521417" y="100127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51 degree 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E291D075-7DC2-D841-83C4-FC5FF34727F3}"/>
                </a:ext>
              </a:extLst>
            </p:cNvPr>
            <p:cNvSpPr txBox="1"/>
            <p:nvPr/>
          </p:nvSpPr>
          <p:spPr>
            <a:xfrm rot="16200000">
              <a:off x="6987653" y="100127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2 degree </a:t>
              </a:r>
            </a:p>
          </p:txBody>
        </p:sp>
      </p:grp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60B6A705-BAEC-7543-8DF9-E3AFDB486F6F}"/>
              </a:ext>
            </a:extLst>
          </p:cNvPr>
          <p:cNvGrpSpPr/>
          <p:nvPr/>
        </p:nvGrpSpPr>
        <p:grpSpPr>
          <a:xfrm>
            <a:off x="1434189" y="133350"/>
            <a:ext cx="5586871" cy="5309793"/>
            <a:chOff x="3944879" y="388387"/>
            <a:chExt cx="5586871" cy="5309793"/>
          </a:xfrm>
        </p:grpSpPr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25012440-1B20-AB46-AB11-E71090B3D867}"/>
                </a:ext>
              </a:extLst>
            </p:cNvPr>
            <p:cNvSpPr txBox="1"/>
            <p:nvPr/>
          </p:nvSpPr>
          <p:spPr>
            <a:xfrm rot="16200000">
              <a:off x="3614140" y="1459866"/>
              <a:ext cx="9941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 kb Ladder</a:t>
              </a:r>
            </a:p>
          </p:txBody>
        </p:sp>
        <p:sp>
          <p:nvSpPr>
            <p:cNvPr id="105" name="Isosceles Triangle 8">
              <a:extLst>
                <a:ext uri="{FF2B5EF4-FFF2-40B4-BE49-F238E27FC236}">
                  <a16:creationId xmlns:a16="http://schemas.microsoft.com/office/drawing/2014/main" id="{8A14CB9B-7CD1-7349-BAC2-97C47E6F77B3}"/>
                </a:ext>
              </a:extLst>
            </p:cNvPr>
            <p:cNvSpPr/>
            <p:nvPr/>
          </p:nvSpPr>
          <p:spPr>
            <a:xfrm rot="16200000">
              <a:off x="9226995" y="3228062"/>
              <a:ext cx="181666" cy="42784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B2DFD683-CDCE-DA46-957B-E3CEF3A1DCE2}"/>
                </a:ext>
              </a:extLst>
            </p:cNvPr>
            <p:cNvSpPr txBox="1"/>
            <p:nvPr/>
          </p:nvSpPr>
          <p:spPr>
            <a:xfrm rot="16200000">
              <a:off x="6431503" y="1115111"/>
              <a:ext cx="16517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2.9 degree 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FF4B9DAE-0FBD-0249-AFF6-3291DE9BDABA}"/>
                </a:ext>
              </a:extLst>
            </p:cNvPr>
            <p:cNvSpPr txBox="1"/>
            <p:nvPr/>
          </p:nvSpPr>
          <p:spPr>
            <a:xfrm rot="16200000">
              <a:off x="6892755" y="1101814"/>
              <a:ext cx="167075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1.0 degree 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9B6E7981-84B9-4E40-9FC3-E4F50A1BB4A3}"/>
                </a:ext>
              </a:extLst>
            </p:cNvPr>
            <p:cNvSpPr txBox="1"/>
            <p:nvPr/>
          </p:nvSpPr>
          <p:spPr>
            <a:xfrm rot="16200000">
              <a:off x="7966157" y="1713455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1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egative 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CE8CA5F8-4F9F-3B44-97E8-58E4F0D0F6B1}"/>
                </a:ext>
              </a:extLst>
            </p:cNvPr>
            <p:cNvSpPr txBox="1"/>
            <p:nvPr/>
          </p:nvSpPr>
          <p:spPr>
            <a:xfrm rot="16200000">
              <a:off x="5383616" y="1111316"/>
              <a:ext cx="16517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9.1 degree 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F941DA6-B073-074E-A645-D32CB9AE91E4}"/>
                </a:ext>
              </a:extLst>
            </p:cNvPr>
            <p:cNvSpPr txBox="1"/>
            <p:nvPr/>
          </p:nvSpPr>
          <p:spPr>
            <a:xfrm rot="16200000">
              <a:off x="5869170" y="1122522"/>
              <a:ext cx="16707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5.7 degree 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572CC72D-AD87-844E-AB2D-186769DDA63A}"/>
                </a:ext>
              </a:extLst>
            </p:cNvPr>
            <p:cNvSpPr txBox="1"/>
            <p:nvPr/>
          </p:nvSpPr>
          <p:spPr>
            <a:xfrm rot="16200000">
              <a:off x="4373714" y="1092956"/>
              <a:ext cx="16707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3.8 degree 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754C4C42-A384-0F47-8F66-02E828EBFD38}"/>
                </a:ext>
              </a:extLst>
            </p:cNvPr>
            <p:cNvSpPr txBox="1"/>
            <p:nvPr/>
          </p:nvSpPr>
          <p:spPr>
            <a:xfrm rot="16200000">
              <a:off x="3842957" y="1138215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5 degree 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B0DA2074-BE74-CD40-AF6F-4F8F9D3B4005}"/>
                </a:ext>
              </a:extLst>
            </p:cNvPr>
            <p:cNvSpPr txBox="1"/>
            <p:nvPr/>
          </p:nvSpPr>
          <p:spPr>
            <a:xfrm rot="16200000">
              <a:off x="4868475" y="115163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2 degree 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4FA3FD32-F3FF-6A4D-8CA2-254DF0811F0F}"/>
                </a:ext>
              </a:extLst>
            </p:cNvPr>
            <p:cNvSpPr txBox="1"/>
            <p:nvPr/>
          </p:nvSpPr>
          <p:spPr>
            <a:xfrm rot="16200000">
              <a:off x="7444002" y="1138214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 degree </a:t>
              </a:r>
            </a:p>
          </p:txBody>
        </p:sp>
        <p:pic>
          <p:nvPicPr>
            <p:cNvPr id="118" name="Picture 117">
              <a:extLst>
                <a:ext uri="{FF2B5EF4-FFF2-40B4-BE49-F238E27FC236}">
                  <a16:creationId xmlns:a16="http://schemas.microsoft.com/office/drawing/2014/main" id="{FF3D112C-41ED-B845-B4C3-C92F348A0E3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44879" y="2009780"/>
              <a:ext cx="5096698" cy="3688400"/>
            </a:xfrm>
            <a:prstGeom prst="rect">
              <a:avLst/>
            </a:prstGeom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D6895489-6FFC-B847-98E6-903365E621C9}"/>
              </a:ext>
            </a:extLst>
          </p:cNvPr>
          <p:cNvGrpSpPr/>
          <p:nvPr/>
        </p:nvGrpSpPr>
        <p:grpSpPr>
          <a:xfrm>
            <a:off x="8865053" y="5353259"/>
            <a:ext cx="4734457" cy="5468806"/>
            <a:chOff x="8588228" y="4930514"/>
            <a:chExt cx="4734457" cy="5468806"/>
          </a:xfrm>
        </p:grpSpPr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A28A1B17-AA78-7442-B4E8-2488EA727AC0}"/>
                </a:ext>
              </a:extLst>
            </p:cNvPr>
            <p:cNvGrpSpPr/>
            <p:nvPr/>
          </p:nvGrpSpPr>
          <p:grpSpPr>
            <a:xfrm>
              <a:off x="8588228" y="4930514"/>
              <a:ext cx="4734457" cy="5468806"/>
              <a:chOff x="3984170" y="303969"/>
              <a:chExt cx="4734457" cy="5468806"/>
            </a:xfrm>
          </p:grpSpPr>
          <p:pic>
            <p:nvPicPr>
              <p:cNvPr id="122" name="Picture 121">
                <a:extLst>
                  <a:ext uri="{FF2B5EF4-FFF2-40B4-BE49-F238E27FC236}">
                    <a16:creationId xmlns:a16="http://schemas.microsoft.com/office/drawing/2014/main" id="{9DD8AF18-5993-7F48-BEB8-6FDCB2E05C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595" t="24398" r="41641" b="16797"/>
              <a:stretch/>
            </p:blipFill>
            <p:spPr>
              <a:xfrm>
                <a:off x="3984170" y="1947224"/>
                <a:ext cx="4734457" cy="3825551"/>
              </a:xfrm>
              <a:prstGeom prst="rect">
                <a:avLst/>
              </a:prstGeom>
            </p:spPr>
          </p:pic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FB715EB4-C728-8D4D-80C8-1F449D33DEFB}"/>
                  </a:ext>
                </a:extLst>
              </p:cNvPr>
              <p:cNvSpPr txBox="1"/>
              <p:nvPr/>
            </p:nvSpPr>
            <p:spPr>
              <a:xfrm rot="16200000">
                <a:off x="3653146" y="1334181"/>
                <a:ext cx="10871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0 bp Ladder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71655C22-061C-5D40-8F3C-C5587000308D}"/>
                  </a:ext>
                </a:extLst>
              </p:cNvPr>
              <p:cNvSpPr txBox="1"/>
              <p:nvPr/>
            </p:nvSpPr>
            <p:spPr>
              <a:xfrm rot="16200000">
                <a:off x="6567534" y="1058352"/>
                <a:ext cx="15711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1 degree </a:t>
                </a: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40585C29-646C-2145-9459-B268FB0766AC}"/>
                  </a:ext>
                </a:extLst>
              </p:cNvPr>
              <p:cNvSpPr txBox="1"/>
              <p:nvPr/>
            </p:nvSpPr>
            <p:spPr>
              <a:xfrm rot="16200000">
                <a:off x="7061001" y="1058352"/>
                <a:ext cx="15711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0 degree </a:t>
                </a: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63BE73E2-36CE-A346-BFE8-ED66468BD2A8}"/>
                  </a:ext>
                </a:extLst>
              </p:cNvPr>
              <p:cNvSpPr txBox="1"/>
              <p:nvPr/>
            </p:nvSpPr>
            <p:spPr>
              <a:xfrm rot="16200000">
                <a:off x="5490006" y="1058352"/>
                <a:ext cx="15711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3 degree </a:t>
                </a: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0B895762-EBDE-284B-B1C2-55B32261B1F6}"/>
                  </a:ext>
                </a:extLst>
              </p:cNvPr>
              <p:cNvSpPr txBox="1"/>
              <p:nvPr/>
            </p:nvSpPr>
            <p:spPr>
              <a:xfrm rot="16200000">
                <a:off x="6032707" y="1058352"/>
                <a:ext cx="15711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2 degree 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F930CBAA-F164-FE4C-8447-62BE11AC462A}"/>
                  </a:ext>
                </a:extLst>
              </p:cNvPr>
              <p:cNvSpPr txBox="1"/>
              <p:nvPr/>
            </p:nvSpPr>
            <p:spPr>
              <a:xfrm rot="16200000">
                <a:off x="4423993" y="1008538"/>
                <a:ext cx="16707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4.5 degree </a:t>
                </a: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DB03567A-53A3-A042-9240-6BCB4AC3B8A4}"/>
                  </a:ext>
                </a:extLst>
              </p:cNvPr>
              <p:cNvSpPr txBox="1"/>
              <p:nvPr/>
            </p:nvSpPr>
            <p:spPr>
              <a:xfrm rot="16200000">
                <a:off x="3946333" y="1058352"/>
                <a:ext cx="15711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5 degree 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8DFBD460-5761-CF40-8FD4-BC23517C137B}"/>
                  </a:ext>
                </a:extLst>
              </p:cNvPr>
              <p:cNvSpPr txBox="1"/>
              <p:nvPr/>
            </p:nvSpPr>
            <p:spPr>
              <a:xfrm rot="16200000">
                <a:off x="4961329" y="1058352"/>
                <a:ext cx="15711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4 degree </a:t>
                </a:r>
              </a:p>
            </p:txBody>
          </p: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28BC029-4DFD-7744-9B2D-BB71880B6D82}"/>
                </a:ext>
              </a:extLst>
            </p:cNvPr>
            <p:cNvSpPr txBox="1"/>
            <p:nvPr/>
          </p:nvSpPr>
          <p:spPr>
            <a:xfrm rot="16200000">
              <a:off x="12255154" y="5690600"/>
              <a:ext cx="15711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egative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3C80C412-F972-554C-AC1E-8120C1D05CDE}"/>
              </a:ext>
            </a:extLst>
          </p:cNvPr>
          <p:cNvSpPr txBox="1"/>
          <p:nvPr/>
        </p:nvSpPr>
        <p:spPr>
          <a:xfrm>
            <a:off x="720773" y="730838"/>
            <a:ext cx="595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2A21888-5955-9C4F-8E50-E4FD3BF79316}"/>
              </a:ext>
            </a:extLst>
          </p:cNvPr>
          <p:cNvSpPr txBox="1"/>
          <p:nvPr/>
        </p:nvSpPr>
        <p:spPr>
          <a:xfrm>
            <a:off x="8311127" y="837589"/>
            <a:ext cx="595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22DB20B-5CC9-074D-8DF8-58F16F4B7D77}"/>
              </a:ext>
            </a:extLst>
          </p:cNvPr>
          <p:cNvSpPr txBox="1"/>
          <p:nvPr/>
        </p:nvSpPr>
        <p:spPr>
          <a:xfrm>
            <a:off x="509424" y="6081498"/>
            <a:ext cx="61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1F1701A-0D69-3B4E-89BA-EF869E54CDBD}"/>
              </a:ext>
            </a:extLst>
          </p:cNvPr>
          <p:cNvSpPr txBox="1"/>
          <p:nvPr/>
        </p:nvSpPr>
        <p:spPr>
          <a:xfrm>
            <a:off x="8176473" y="6081498"/>
            <a:ext cx="61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97846B7-5A88-2B43-BC8C-FC04990084D1}"/>
              </a:ext>
            </a:extLst>
          </p:cNvPr>
          <p:cNvSpPr txBox="1"/>
          <p:nvPr/>
        </p:nvSpPr>
        <p:spPr>
          <a:xfrm>
            <a:off x="2723955" y="427346"/>
            <a:ext cx="26054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P-1 Primer (112bp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4320ED1-AC9B-D844-90A0-02B94EFD7875}"/>
              </a:ext>
            </a:extLst>
          </p:cNvPr>
          <p:cNvSpPr txBox="1"/>
          <p:nvPr/>
        </p:nvSpPr>
        <p:spPr>
          <a:xfrm>
            <a:off x="9306770" y="418699"/>
            <a:ext cx="26901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P-4 Primer (134 bp)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7980833-570E-634C-83D4-832FDFB0E91A}"/>
              </a:ext>
            </a:extLst>
          </p:cNvPr>
          <p:cNvSpPr txBox="1"/>
          <p:nvPr/>
        </p:nvSpPr>
        <p:spPr>
          <a:xfrm>
            <a:off x="2554683" y="5911499"/>
            <a:ext cx="23054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N1 Primer (72 bp)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2F8A985-6F0C-5745-B332-0C74A363113A}"/>
              </a:ext>
            </a:extLst>
          </p:cNvPr>
          <p:cNvSpPr txBox="1"/>
          <p:nvPr/>
        </p:nvSpPr>
        <p:spPr>
          <a:xfrm>
            <a:off x="9721364" y="5819557"/>
            <a:ext cx="26904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NP-1 Primer (114 bp)</a:t>
            </a:r>
          </a:p>
        </p:txBody>
      </p:sp>
      <p:sp>
        <p:nvSpPr>
          <p:cNvPr id="68" name="Isosceles Triangle 8">
            <a:extLst>
              <a:ext uri="{FF2B5EF4-FFF2-40B4-BE49-F238E27FC236}">
                <a16:creationId xmlns:a16="http://schemas.microsoft.com/office/drawing/2014/main" id="{B777D32E-933E-F748-8B5B-621E2CC35E82}"/>
              </a:ext>
            </a:extLst>
          </p:cNvPr>
          <p:cNvSpPr/>
          <p:nvPr/>
        </p:nvSpPr>
        <p:spPr>
          <a:xfrm rot="16200000">
            <a:off x="12569333" y="2791359"/>
            <a:ext cx="181666" cy="42784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Isosceles Triangle 8">
            <a:extLst>
              <a:ext uri="{FF2B5EF4-FFF2-40B4-BE49-F238E27FC236}">
                <a16:creationId xmlns:a16="http://schemas.microsoft.com/office/drawing/2014/main" id="{D2D87CE1-FE51-FC4B-8506-8EFBFD56D72A}"/>
              </a:ext>
            </a:extLst>
          </p:cNvPr>
          <p:cNvSpPr/>
          <p:nvPr/>
        </p:nvSpPr>
        <p:spPr>
          <a:xfrm rot="16200000">
            <a:off x="6716305" y="8604533"/>
            <a:ext cx="181666" cy="42784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Isosceles Triangle 8">
            <a:extLst>
              <a:ext uri="{FF2B5EF4-FFF2-40B4-BE49-F238E27FC236}">
                <a16:creationId xmlns:a16="http://schemas.microsoft.com/office/drawing/2014/main" id="{BF880229-E8B1-E246-BABD-91A8E5FF11A2}"/>
              </a:ext>
            </a:extLst>
          </p:cNvPr>
          <p:cNvSpPr/>
          <p:nvPr/>
        </p:nvSpPr>
        <p:spPr>
          <a:xfrm rot="16200000">
            <a:off x="13733261" y="8242583"/>
            <a:ext cx="181666" cy="42784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B7944B-985A-164E-B561-4ACE8692C9E6}"/>
              </a:ext>
            </a:extLst>
          </p:cNvPr>
          <p:cNvSpPr txBox="1"/>
          <p:nvPr/>
        </p:nvSpPr>
        <p:spPr>
          <a:xfrm>
            <a:off x="38706" y="36362"/>
            <a:ext cx="1585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302853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</TotalTime>
  <Words>109</Words>
  <Application>Microsoft Macintosh PowerPoint</Application>
  <PresentationFormat>Custom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veer Ahmed</dc:creator>
  <cp:lastModifiedBy>Tanveer Ahmed</cp:lastModifiedBy>
  <cp:revision>9</cp:revision>
  <cp:lastPrinted>2020-11-09T05:56:50Z</cp:lastPrinted>
  <dcterms:created xsi:type="dcterms:W3CDTF">2020-10-26T11:46:33Z</dcterms:created>
  <dcterms:modified xsi:type="dcterms:W3CDTF">2021-01-17T13:59:11Z</dcterms:modified>
</cp:coreProperties>
</file>